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261" r:id="rId2"/>
    <p:sldId id="262" r:id="rId3"/>
    <p:sldId id="263" r:id="rId4"/>
    <p:sldId id="264" r:id="rId5"/>
    <p:sldId id="265" r:id="rId6"/>
    <p:sldId id="266" r:id="rId7"/>
    <p:sldId id="267" r:id="rId8"/>
    <p:sldId id="268" r:id="rId9"/>
    <p:sldId id="269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5091"/>
  </p:normalViewPr>
  <p:slideViewPr>
    <p:cSldViewPr snapToGrid="0">
      <p:cViewPr varScale="1">
        <p:scale>
          <a:sx n="89" d="100"/>
          <a:sy n="89" d="100"/>
        </p:scale>
        <p:origin x="89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aik, Seo (NIH/NLM/LHC) [E]" userId="7a9ca21e-0617-4b6c-a5ae-fc5f2cb02f0b" providerId="ADAL" clId="{93773643-05EC-1E41-955C-3FA235084F8F}"/>
    <pc:docChg chg="undo custSel modSld">
      <pc:chgData name="Baik, Seo (NIH/NLM/LHC) [E]" userId="7a9ca21e-0617-4b6c-a5ae-fc5f2cb02f0b" providerId="ADAL" clId="{93773643-05EC-1E41-955C-3FA235084F8F}" dt="2023-04-26T14:40:15.094" v="14" actId="20577"/>
      <pc:docMkLst>
        <pc:docMk/>
      </pc:docMkLst>
      <pc:sldChg chg="addSp modSp mod">
        <pc:chgData name="Baik, Seo (NIH/NLM/LHC) [E]" userId="7a9ca21e-0617-4b6c-a5ae-fc5f2cb02f0b" providerId="ADAL" clId="{93773643-05EC-1E41-955C-3FA235084F8F}" dt="2023-04-26T14:40:15.094" v="14" actId="20577"/>
        <pc:sldMkLst>
          <pc:docMk/>
          <pc:sldMk cId="1485791901" sldId="261"/>
        </pc:sldMkLst>
        <pc:spChg chg="add mod">
          <ac:chgData name="Baik, Seo (NIH/NLM/LHC) [E]" userId="7a9ca21e-0617-4b6c-a5ae-fc5f2cb02f0b" providerId="ADAL" clId="{93773643-05EC-1E41-955C-3FA235084F8F}" dt="2023-04-26T14:40:15.094" v="14" actId="20577"/>
          <ac:spMkLst>
            <pc:docMk/>
            <pc:sldMk cId="1485791901" sldId="261"/>
            <ac:spMk id="4" creationId="{CFEF91FA-443F-86FA-0F09-51DEC24CBC85}"/>
          </ac:spMkLst>
        </pc:spChg>
        <pc:spChg chg="mod">
          <ac:chgData name="Baik, Seo (NIH/NLM/LHC) [E]" userId="7a9ca21e-0617-4b6c-a5ae-fc5f2cb02f0b" providerId="ADAL" clId="{93773643-05EC-1E41-955C-3FA235084F8F}" dt="2023-04-18T20:08:31.646" v="9" actId="1076"/>
          <ac:spMkLst>
            <pc:docMk/>
            <pc:sldMk cId="1485791901" sldId="261"/>
            <ac:spMk id="8" creationId="{2C5B2A98-1A99-D6D7-79F4-0AC3634FB316}"/>
          </ac:spMkLst>
        </pc:spChg>
        <pc:spChg chg="mod">
          <ac:chgData name="Baik, Seo (NIH/NLM/LHC) [E]" userId="7a9ca21e-0617-4b6c-a5ae-fc5f2cb02f0b" providerId="ADAL" clId="{93773643-05EC-1E41-955C-3FA235084F8F}" dt="2023-04-18T20:08:38.962" v="10" actId="1076"/>
          <ac:spMkLst>
            <pc:docMk/>
            <pc:sldMk cId="1485791901" sldId="261"/>
            <ac:spMk id="9" creationId="{130245B5-E599-D50F-7A48-B2A4886489CD}"/>
          </ac:spMkLst>
        </pc:spChg>
        <pc:picChg chg="mod">
          <ac:chgData name="Baik, Seo (NIH/NLM/LHC) [E]" userId="7a9ca21e-0617-4b6c-a5ae-fc5f2cb02f0b" providerId="ADAL" clId="{93773643-05EC-1E41-955C-3FA235084F8F}" dt="2023-04-18T20:08:24.848" v="7" actId="1076"/>
          <ac:picMkLst>
            <pc:docMk/>
            <pc:sldMk cId="1485791901" sldId="261"/>
            <ac:picMk id="2" creationId="{00000000-0008-0000-0B00-00005D000000}"/>
          </ac:picMkLst>
        </pc:picChg>
        <pc:picChg chg="mod">
          <ac:chgData name="Baik, Seo (NIH/NLM/LHC) [E]" userId="7a9ca21e-0617-4b6c-a5ae-fc5f2cb02f0b" providerId="ADAL" clId="{93773643-05EC-1E41-955C-3FA235084F8F}" dt="2023-04-18T20:08:27.612" v="8" actId="1076"/>
          <ac:picMkLst>
            <pc:docMk/>
            <pc:sldMk cId="1485791901" sldId="261"/>
            <ac:picMk id="3" creationId="{00000000-0008-0000-0B00-0000B2000000}"/>
          </ac:picMkLst>
        </pc:picChg>
      </pc:sldChg>
    </pc:docChg>
  </pc:docChgLst>
  <pc:docChgLst>
    <pc:chgData name="Baik, Seo (NIH/NLM/LHC) [E]" userId="7a9ca21e-0617-4b6c-a5ae-fc5f2cb02f0b" providerId="ADAL" clId="{FD0A2BAE-B4E8-E047-B22D-0A9EBACDEB7A}"/>
    <pc:docChg chg="modSld">
      <pc:chgData name="Baik, Seo (NIH/NLM/LHC) [E]" userId="7a9ca21e-0617-4b6c-a5ae-fc5f2cb02f0b" providerId="ADAL" clId="{FD0A2BAE-B4E8-E047-B22D-0A9EBACDEB7A}" dt="2023-09-01T14:29:40.822" v="6" actId="20577"/>
      <pc:docMkLst>
        <pc:docMk/>
      </pc:docMkLst>
      <pc:sldChg chg="modSp mod">
        <pc:chgData name="Baik, Seo (NIH/NLM/LHC) [E]" userId="7a9ca21e-0617-4b6c-a5ae-fc5f2cb02f0b" providerId="ADAL" clId="{FD0A2BAE-B4E8-E047-B22D-0A9EBACDEB7A}" dt="2023-09-01T14:29:40.822" v="6" actId="20577"/>
        <pc:sldMkLst>
          <pc:docMk/>
          <pc:sldMk cId="1485791901" sldId="261"/>
        </pc:sldMkLst>
        <pc:spChg chg="mod">
          <ac:chgData name="Baik, Seo (NIH/NLM/LHC) [E]" userId="7a9ca21e-0617-4b6c-a5ae-fc5f2cb02f0b" providerId="ADAL" clId="{FD0A2BAE-B4E8-E047-B22D-0A9EBACDEB7A}" dt="2023-09-01T14:29:40.822" v="6" actId="20577"/>
          <ac:spMkLst>
            <pc:docMk/>
            <pc:sldMk cId="1485791901" sldId="261"/>
            <ac:spMk id="4" creationId="{CFEF91FA-443F-86FA-0F09-51DEC24CBC85}"/>
          </ac:spMkLst>
        </pc:spChg>
      </pc:sldChg>
    </pc:docChg>
  </pc:docChgLst>
  <pc:docChgLst>
    <pc:chgData name="Baik, Seo (NIH/NLM/LHC) [E]" userId="7a9ca21e-0617-4b6c-a5ae-fc5f2cb02f0b" providerId="ADAL" clId="{9DC89E1D-07DD-CF46-AC53-78DEFA578F9A}"/>
    <pc:docChg chg="addSld delSld modSld sldOrd">
      <pc:chgData name="Baik, Seo (NIH/NLM/LHC) [E]" userId="7a9ca21e-0617-4b6c-a5ae-fc5f2cb02f0b" providerId="ADAL" clId="{9DC89E1D-07DD-CF46-AC53-78DEFA578F9A}" dt="2023-04-07T19:15:27.801" v="36" actId="2696"/>
      <pc:docMkLst>
        <pc:docMk/>
      </pc:docMkLst>
      <pc:sldChg chg="add del ord">
        <pc:chgData name="Baik, Seo (NIH/NLM/LHC) [E]" userId="7a9ca21e-0617-4b6c-a5ae-fc5f2cb02f0b" providerId="ADAL" clId="{9DC89E1D-07DD-CF46-AC53-78DEFA578F9A}" dt="2023-04-07T19:15:27.801" v="36" actId="2696"/>
        <pc:sldMkLst>
          <pc:docMk/>
          <pc:sldMk cId="775985696" sldId="256"/>
        </pc:sldMkLst>
      </pc:sldChg>
      <pc:sldChg chg="modSp mod">
        <pc:chgData name="Baik, Seo (NIH/NLM/LHC) [E]" userId="7a9ca21e-0617-4b6c-a5ae-fc5f2cb02f0b" providerId="ADAL" clId="{9DC89E1D-07DD-CF46-AC53-78DEFA578F9A}" dt="2023-03-23T15:21:22.996" v="2" actId="20577"/>
        <pc:sldMkLst>
          <pc:docMk/>
          <pc:sldMk cId="1485791901" sldId="261"/>
        </pc:sldMkLst>
        <pc:spChg chg="mod">
          <ac:chgData name="Baik, Seo (NIH/NLM/LHC) [E]" userId="7a9ca21e-0617-4b6c-a5ae-fc5f2cb02f0b" providerId="ADAL" clId="{9DC89E1D-07DD-CF46-AC53-78DEFA578F9A}" dt="2023-03-23T15:21:19.094" v="0" actId="20577"/>
          <ac:spMkLst>
            <pc:docMk/>
            <pc:sldMk cId="1485791901" sldId="261"/>
            <ac:spMk id="8" creationId="{2C5B2A98-1A99-D6D7-79F4-0AC3634FB316}"/>
          </ac:spMkLst>
        </pc:spChg>
        <pc:spChg chg="mod">
          <ac:chgData name="Baik, Seo (NIH/NLM/LHC) [E]" userId="7a9ca21e-0617-4b6c-a5ae-fc5f2cb02f0b" providerId="ADAL" clId="{9DC89E1D-07DD-CF46-AC53-78DEFA578F9A}" dt="2023-03-23T15:21:22.996" v="2" actId="20577"/>
          <ac:spMkLst>
            <pc:docMk/>
            <pc:sldMk cId="1485791901" sldId="261"/>
            <ac:spMk id="9" creationId="{130245B5-E599-D50F-7A48-B2A4886489CD}"/>
          </ac:spMkLst>
        </pc:spChg>
      </pc:sldChg>
      <pc:sldChg chg="modSp mod">
        <pc:chgData name="Baik, Seo (NIH/NLM/LHC) [E]" userId="7a9ca21e-0617-4b6c-a5ae-fc5f2cb02f0b" providerId="ADAL" clId="{9DC89E1D-07DD-CF46-AC53-78DEFA578F9A}" dt="2023-03-23T15:21:31.796" v="6" actId="20577"/>
        <pc:sldMkLst>
          <pc:docMk/>
          <pc:sldMk cId="2639092285" sldId="262"/>
        </pc:sldMkLst>
        <pc:spChg chg="mod">
          <ac:chgData name="Baik, Seo (NIH/NLM/LHC) [E]" userId="7a9ca21e-0617-4b6c-a5ae-fc5f2cb02f0b" providerId="ADAL" clId="{9DC89E1D-07DD-CF46-AC53-78DEFA578F9A}" dt="2023-03-23T15:21:28.803" v="4" actId="20577"/>
          <ac:spMkLst>
            <pc:docMk/>
            <pc:sldMk cId="2639092285" sldId="262"/>
            <ac:spMk id="8" creationId="{2C5B2A98-1A99-D6D7-79F4-0AC3634FB316}"/>
          </ac:spMkLst>
        </pc:spChg>
        <pc:spChg chg="mod">
          <ac:chgData name="Baik, Seo (NIH/NLM/LHC) [E]" userId="7a9ca21e-0617-4b6c-a5ae-fc5f2cb02f0b" providerId="ADAL" clId="{9DC89E1D-07DD-CF46-AC53-78DEFA578F9A}" dt="2023-03-23T15:21:31.796" v="6" actId="20577"/>
          <ac:spMkLst>
            <pc:docMk/>
            <pc:sldMk cId="2639092285" sldId="262"/>
            <ac:spMk id="9" creationId="{130245B5-E599-D50F-7A48-B2A4886489CD}"/>
          </ac:spMkLst>
        </pc:spChg>
      </pc:sldChg>
      <pc:sldChg chg="modSp mod">
        <pc:chgData name="Baik, Seo (NIH/NLM/LHC) [E]" userId="7a9ca21e-0617-4b6c-a5ae-fc5f2cb02f0b" providerId="ADAL" clId="{9DC89E1D-07DD-CF46-AC53-78DEFA578F9A}" dt="2023-03-23T15:21:36.389" v="8" actId="20577"/>
        <pc:sldMkLst>
          <pc:docMk/>
          <pc:sldMk cId="1114006434" sldId="263"/>
        </pc:sldMkLst>
        <pc:spChg chg="mod">
          <ac:chgData name="Baik, Seo (NIH/NLM/LHC) [E]" userId="7a9ca21e-0617-4b6c-a5ae-fc5f2cb02f0b" providerId="ADAL" clId="{9DC89E1D-07DD-CF46-AC53-78DEFA578F9A}" dt="2023-03-23T15:21:36.389" v="8" actId="20577"/>
          <ac:spMkLst>
            <pc:docMk/>
            <pc:sldMk cId="1114006434" sldId="263"/>
            <ac:spMk id="8" creationId="{2C5B2A98-1A99-D6D7-79F4-0AC3634FB316}"/>
          </ac:spMkLst>
        </pc:spChg>
      </pc:sldChg>
      <pc:sldChg chg="modSp mod">
        <pc:chgData name="Baik, Seo (NIH/NLM/LHC) [E]" userId="7a9ca21e-0617-4b6c-a5ae-fc5f2cb02f0b" providerId="ADAL" clId="{9DC89E1D-07DD-CF46-AC53-78DEFA578F9A}" dt="2023-03-23T15:21:46.661" v="13" actId="20577"/>
        <pc:sldMkLst>
          <pc:docMk/>
          <pc:sldMk cId="2554534204" sldId="264"/>
        </pc:sldMkLst>
        <pc:spChg chg="mod">
          <ac:chgData name="Baik, Seo (NIH/NLM/LHC) [E]" userId="7a9ca21e-0617-4b6c-a5ae-fc5f2cb02f0b" providerId="ADAL" clId="{9DC89E1D-07DD-CF46-AC53-78DEFA578F9A}" dt="2023-03-23T15:21:43.947" v="11" actId="14100"/>
          <ac:spMkLst>
            <pc:docMk/>
            <pc:sldMk cId="2554534204" sldId="264"/>
            <ac:spMk id="8" creationId="{2C5B2A98-1A99-D6D7-79F4-0AC3634FB316}"/>
          </ac:spMkLst>
        </pc:spChg>
        <pc:spChg chg="mod">
          <ac:chgData name="Baik, Seo (NIH/NLM/LHC) [E]" userId="7a9ca21e-0617-4b6c-a5ae-fc5f2cb02f0b" providerId="ADAL" clId="{9DC89E1D-07DD-CF46-AC53-78DEFA578F9A}" dt="2023-03-23T15:21:46.661" v="13" actId="20577"/>
          <ac:spMkLst>
            <pc:docMk/>
            <pc:sldMk cId="2554534204" sldId="264"/>
            <ac:spMk id="9" creationId="{130245B5-E599-D50F-7A48-B2A4886489CD}"/>
          </ac:spMkLst>
        </pc:spChg>
      </pc:sldChg>
      <pc:sldChg chg="modSp mod">
        <pc:chgData name="Baik, Seo (NIH/NLM/LHC) [E]" userId="7a9ca21e-0617-4b6c-a5ae-fc5f2cb02f0b" providerId="ADAL" clId="{9DC89E1D-07DD-CF46-AC53-78DEFA578F9A}" dt="2023-03-23T15:21:54.500" v="17" actId="20577"/>
        <pc:sldMkLst>
          <pc:docMk/>
          <pc:sldMk cId="3898104577" sldId="265"/>
        </pc:sldMkLst>
        <pc:spChg chg="mod">
          <ac:chgData name="Baik, Seo (NIH/NLM/LHC) [E]" userId="7a9ca21e-0617-4b6c-a5ae-fc5f2cb02f0b" providerId="ADAL" clId="{9DC89E1D-07DD-CF46-AC53-78DEFA578F9A}" dt="2023-03-23T15:21:50.835" v="15" actId="20577"/>
          <ac:spMkLst>
            <pc:docMk/>
            <pc:sldMk cId="3898104577" sldId="265"/>
            <ac:spMk id="8" creationId="{2C5B2A98-1A99-D6D7-79F4-0AC3634FB316}"/>
          </ac:spMkLst>
        </pc:spChg>
        <pc:spChg chg="mod">
          <ac:chgData name="Baik, Seo (NIH/NLM/LHC) [E]" userId="7a9ca21e-0617-4b6c-a5ae-fc5f2cb02f0b" providerId="ADAL" clId="{9DC89E1D-07DD-CF46-AC53-78DEFA578F9A}" dt="2023-03-23T15:21:54.500" v="17" actId="20577"/>
          <ac:spMkLst>
            <pc:docMk/>
            <pc:sldMk cId="3898104577" sldId="265"/>
            <ac:spMk id="9" creationId="{130245B5-E599-D50F-7A48-B2A4886489CD}"/>
          </ac:spMkLst>
        </pc:spChg>
      </pc:sldChg>
      <pc:sldChg chg="modSp mod">
        <pc:chgData name="Baik, Seo (NIH/NLM/LHC) [E]" userId="7a9ca21e-0617-4b6c-a5ae-fc5f2cb02f0b" providerId="ADAL" clId="{9DC89E1D-07DD-CF46-AC53-78DEFA578F9A}" dt="2023-03-23T15:22:03.060" v="21" actId="20577"/>
        <pc:sldMkLst>
          <pc:docMk/>
          <pc:sldMk cId="830784188" sldId="266"/>
        </pc:sldMkLst>
        <pc:spChg chg="mod">
          <ac:chgData name="Baik, Seo (NIH/NLM/LHC) [E]" userId="7a9ca21e-0617-4b6c-a5ae-fc5f2cb02f0b" providerId="ADAL" clId="{9DC89E1D-07DD-CF46-AC53-78DEFA578F9A}" dt="2023-03-23T15:21:59.444" v="19" actId="20577"/>
          <ac:spMkLst>
            <pc:docMk/>
            <pc:sldMk cId="830784188" sldId="266"/>
            <ac:spMk id="8" creationId="{2C5B2A98-1A99-D6D7-79F4-0AC3634FB316}"/>
          </ac:spMkLst>
        </pc:spChg>
        <pc:spChg chg="mod">
          <ac:chgData name="Baik, Seo (NIH/NLM/LHC) [E]" userId="7a9ca21e-0617-4b6c-a5ae-fc5f2cb02f0b" providerId="ADAL" clId="{9DC89E1D-07DD-CF46-AC53-78DEFA578F9A}" dt="2023-03-23T15:22:03.060" v="21" actId="20577"/>
          <ac:spMkLst>
            <pc:docMk/>
            <pc:sldMk cId="830784188" sldId="266"/>
            <ac:spMk id="9" creationId="{130245B5-E599-D50F-7A48-B2A4886489CD}"/>
          </ac:spMkLst>
        </pc:spChg>
      </pc:sldChg>
      <pc:sldChg chg="modSp mod">
        <pc:chgData name="Baik, Seo (NIH/NLM/LHC) [E]" userId="7a9ca21e-0617-4b6c-a5ae-fc5f2cb02f0b" providerId="ADAL" clId="{9DC89E1D-07DD-CF46-AC53-78DEFA578F9A}" dt="2023-03-23T15:22:14.487" v="25" actId="20577"/>
        <pc:sldMkLst>
          <pc:docMk/>
          <pc:sldMk cId="3684001503" sldId="267"/>
        </pc:sldMkLst>
        <pc:spChg chg="mod">
          <ac:chgData name="Baik, Seo (NIH/NLM/LHC) [E]" userId="7a9ca21e-0617-4b6c-a5ae-fc5f2cb02f0b" providerId="ADAL" clId="{9DC89E1D-07DD-CF46-AC53-78DEFA578F9A}" dt="2023-03-23T15:22:11.556" v="23" actId="20577"/>
          <ac:spMkLst>
            <pc:docMk/>
            <pc:sldMk cId="3684001503" sldId="267"/>
            <ac:spMk id="8" creationId="{2C5B2A98-1A99-D6D7-79F4-0AC3634FB316}"/>
          </ac:spMkLst>
        </pc:spChg>
        <pc:spChg chg="mod">
          <ac:chgData name="Baik, Seo (NIH/NLM/LHC) [E]" userId="7a9ca21e-0617-4b6c-a5ae-fc5f2cb02f0b" providerId="ADAL" clId="{9DC89E1D-07DD-CF46-AC53-78DEFA578F9A}" dt="2023-03-23T15:22:14.487" v="25" actId="20577"/>
          <ac:spMkLst>
            <pc:docMk/>
            <pc:sldMk cId="3684001503" sldId="267"/>
            <ac:spMk id="9" creationId="{130245B5-E599-D50F-7A48-B2A4886489CD}"/>
          </ac:spMkLst>
        </pc:spChg>
      </pc:sldChg>
      <pc:sldChg chg="modSp mod">
        <pc:chgData name="Baik, Seo (NIH/NLM/LHC) [E]" userId="7a9ca21e-0617-4b6c-a5ae-fc5f2cb02f0b" providerId="ADAL" clId="{9DC89E1D-07DD-CF46-AC53-78DEFA578F9A}" dt="2023-03-23T15:22:21.828" v="29" actId="20577"/>
        <pc:sldMkLst>
          <pc:docMk/>
          <pc:sldMk cId="2196059019" sldId="268"/>
        </pc:sldMkLst>
        <pc:spChg chg="mod">
          <ac:chgData name="Baik, Seo (NIH/NLM/LHC) [E]" userId="7a9ca21e-0617-4b6c-a5ae-fc5f2cb02f0b" providerId="ADAL" clId="{9DC89E1D-07DD-CF46-AC53-78DEFA578F9A}" dt="2023-03-23T15:22:18.646" v="27" actId="20577"/>
          <ac:spMkLst>
            <pc:docMk/>
            <pc:sldMk cId="2196059019" sldId="268"/>
            <ac:spMk id="8" creationId="{2C5B2A98-1A99-D6D7-79F4-0AC3634FB316}"/>
          </ac:spMkLst>
        </pc:spChg>
        <pc:spChg chg="mod">
          <ac:chgData name="Baik, Seo (NIH/NLM/LHC) [E]" userId="7a9ca21e-0617-4b6c-a5ae-fc5f2cb02f0b" providerId="ADAL" clId="{9DC89E1D-07DD-CF46-AC53-78DEFA578F9A}" dt="2023-03-23T15:22:21.828" v="29" actId="20577"/>
          <ac:spMkLst>
            <pc:docMk/>
            <pc:sldMk cId="2196059019" sldId="268"/>
            <ac:spMk id="9" creationId="{130245B5-E599-D50F-7A48-B2A4886489CD}"/>
          </ac:spMkLst>
        </pc:spChg>
      </pc:sldChg>
      <pc:sldChg chg="modSp mod">
        <pc:chgData name="Baik, Seo (NIH/NLM/LHC) [E]" userId="7a9ca21e-0617-4b6c-a5ae-fc5f2cb02f0b" providerId="ADAL" clId="{9DC89E1D-07DD-CF46-AC53-78DEFA578F9A}" dt="2023-03-23T15:22:28.789" v="33" actId="20577"/>
        <pc:sldMkLst>
          <pc:docMk/>
          <pc:sldMk cId="16193222" sldId="269"/>
        </pc:sldMkLst>
        <pc:spChg chg="mod">
          <ac:chgData name="Baik, Seo (NIH/NLM/LHC) [E]" userId="7a9ca21e-0617-4b6c-a5ae-fc5f2cb02f0b" providerId="ADAL" clId="{9DC89E1D-07DD-CF46-AC53-78DEFA578F9A}" dt="2023-03-23T15:22:25.750" v="31" actId="20577"/>
          <ac:spMkLst>
            <pc:docMk/>
            <pc:sldMk cId="16193222" sldId="269"/>
            <ac:spMk id="8" creationId="{2C5B2A98-1A99-D6D7-79F4-0AC3634FB316}"/>
          </ac:spMkLst>
        </pc:spChg>
        <pc:spChg chg="mod">
          <ac:chgData name="Baik, Seo (NIH/NLM/LHC) [E]" userId="7a9ca21e-0617-4b6c-a5ae-fc5f2cb02f0b" providerId="ADAL" clId="{9DC89E1D-07DD-CF46-AC53-78DEFA578F9A}" dt="2023-03-23T15:22:28.789" v="33" actId="20577"/>
          <ac:spMkLst>
            <pc:docMk/>
            <pc:sldMk cId="16193222" sldId="269"/>
            <ac:spMk id="9" creationId="{130245B5-E599-D50F-7A48-B2A4886489CD}"/>
          </ac:spMkLst>
        </pc:spChg>
      </pc:sldChg>
    </pc:docChg>
  </pc:docChgLst>
  <pc:docChgLst>
    <pc:chgData name="Baik, Seo (NIH/NLM/LHC) [E]" userId="7a9ca21e-0617-4b6c-a5ae-fc5f2cb02f0b" providerId="ADAL" clId="{C5F38C62-6709-3643-8CD3-695DC74EDA5A}"/>
    <pc:docChg chg="modSld">
      <pc:chgData name="Baik, Seo (NIH/NLM/LHC) [E]" userId="7a9ca21e-0617-4b6c-a5ae-fc5f2cb02f0b" providerId="ADAL" clId="{C5F38C62-6709-3643-8CD3-695DC74EDA5A}" dt="2023-04-26T14:41:03.510" v="0" actId="20577"/>
      <pc:docMkLst>
        <pc:docMk/>
      </pc:docMkLst>
      <pc:sldChg chg="modSp mod">
        <pc:chgData name="Baik, Seo (NIH/NLM/LHC) [E]" userId="7a9ca21e-0617-4b6c-a5ae-fc5f2cb02f0b" providerId="ADAL" clId="{C5F38C62-6709-3643-8CD3-695DC74EDA5A}" dt="2023-04-26T14:41:03.510" v="0" actId="20577"/>
        <pc:sldMkLst>
          <pc:docMk/>
          <pc:sldMk cId="1485791901" sldId="261"/>
        </pc:sldMkLst>
        <pc:spChg chg="mod">
          <ac:chgData name="Baik, Seo (NIH/NLM/LHC) [E]" userId="7a9ca21e-0617-4b6c-a5ae-fc5f2cb02f0b" providerId="ADAL" clId="{C5F38C62-6709-3643-8CD3-695DC74EDA5A}" dt="2023-04-26T14:41:03.510" v="0" actId="20577"/>
          <ac:spMkLst>
            <pc:docMk/>
            <pc:sldMk cId="1485791901" sldId="261"/>
            <ac:spMk id="4" creationId="{CFEF91FA-443F-86FA-0F09-51DEC24CBC85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FF7743-B154-8B4F-8402-6E55D2D17121}" type="datetimeFigureOut">
              <a:rPr lang="en-US" smtClean="0"/>
              <a:t>9/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9791B2-8DFA-D747-A275-370871B28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5669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4927E3-74E7-684B-82F6-7F35E7D9553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5508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4927E3-74E7-684B-82F6-7F35E7D9553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62028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4927E3-74E7-684B-82F6-7F35E7D9553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39132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4927E3-74E7-684B-82F6-7F35E7D9553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70232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4927E3-74E7-684B-82F6-7F35E7D9553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22142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4927E3-74E7-684B-82F6-7F35E7D9553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0928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4927E3-74E7-684B-82F6-7F35E7D9553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66208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4927E3-74E7-684B-82F6-7F35E7D9553A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50189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4927E3-74E7-684B-82F6-7F35E7D9553A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5329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A63774-DE7A-FEF1-9C5B-61EC691500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34E6D1-9267-D318-AFA7-C576A32F91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F686BC-8514-DEDE-7D58-424284D8B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EE7012-EEB8-4A8E-ADB7-A31D1D777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2A3893-5D2F-A004-474E-7D0DCDDB0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825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F0CA10-1057-6881-DAD9-2A3E7C0495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0DA373-240D-A18E-FCB2-B9B954706A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480D00-EECA-A57D-15FA-168B98016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09F343-42F8-7476-617C-1DB987C5BF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D7FD80-8366-4CF8-06F7-65204C660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845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AD3DA8-5205-658A-B5B6-3D9D8E0871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D92A76-B4C2-756C-260F-495003E0FE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AF1C4B-9EDB-4472-5DC0-D25A64C66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908F08-FC9F-DF77-8187-F222C8381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519E5A-3997-C3AB-EEE2-E2F00DD43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387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232D98-5B84-4A7F-883D-8392C8D8F6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1164FA-2C1A-FE49-DA1A-307C48AC99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894250-F94F-8506-1BFE-01A03500D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1E470C-BAC3-284F-1920-84A2F0D73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814295-CB19-16F1-745F-69F20E662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330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91B4C1-1445-4C67-EC8D-8617DC0CA8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68149F-829D-AC45-3CC1-DFC3E2E0AE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48C152-6C17-EA02-47FF-9594BC526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7B7F9A-8DD4-7FCC-B53C-5E0934707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60097E-254D-FCA4-8464-F00DAA146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930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6FF1B6-24B5-C8DE-B4E0-4D2246C42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583E25-7372-D667-333D-4A3EC0F4C0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1A6F42-7BCB-02E4-F695-EAE3682B45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9EA269-E8D8-2E3C-D42E-FA51C68CF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A98E5E-C55C-B1EB-CA9B-C2B5C0E68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8CF63B-D576-F8C2-38B7-5199D7440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76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A3673F-8E7B-B249-7CF2-E98B89B5E2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4ED33B-3918-BF12-F876-B045840D1E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BB4936-CCD2-3532-376C-D85D7DB88C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47ED8B-705A-A2D5-58BD-264E433389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B4760F0-0654-2E9E-7870-E0A2466FA9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1A41CF-C22D-3072-65DB-123B5FA44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81FF783-6C5E-6F50-7A6A-E14E64404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12B5F7-1558-423B-D615-6147550AF3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625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9B5FEF-C65F-30BC-90F7-FE9523EA55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4C5B0D-791F-C271-502C-44942E2DE3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47AF4AE-AAF6-D79A-7232-41094FF92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B764C6-0625-6DA6-8AE1-F78EEF1D6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585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58C202-07F3-BE7B-FF0D-AB0933963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2CF2583-6AE9-9018-E26D-655E42D32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C256DC-7F2A-0F8A-90FB-04C1D52DA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977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837707-A3B7-EBD8-3E92-1A623EC8CB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8292F9-CB07-EF92-0582-4AAB75FA17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BD70F8-6061-598A-C3B7-6C6F974F3F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83A267-E1CC-735B-7DC1-E5565C587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A24F4C-5634-590D-2295-302FC27A02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C13BD6-0054-35EE-373D-C7E4D8EE5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050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5D24A6-496E-5D78-5E1C-4D7200A69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48F9212-3E95-9F71-DABF-F0F0DE969F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7EE2D3-9EE4-FE83-EBBD-94FD40386D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38C120-D1A7-2810-27EB-62191E0E0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D69721-5BE5-7DFD-F5F0-3FE3CBA6C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2AB731-00A4-EC5E-E6B2-D50E9F10B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500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39C4D58-82C2-E506-676E-07DA08998C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309700-9263-CA0F-29AD-AB01A737B1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60DE43-9415-2272-8999-B7178C5717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45BE11-6C2A-4E4B-90B9-CDFBE41871D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82DBC9-9BCA-378F-1BB7-B8E0769216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D668D5-D3FB-1133-D2A6-6077082F69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024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242686" y="760058"/>
            <a:ext cx="1776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$ Acute Inpatien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0245B5-E599-D50F-7A48-B2A4886489CD}"/>
              </a:ext>
            </a:extLst>
          </p:cNvPr>
          <p:cNvSpPr txBox="1"/>
          <p:nvPr/>
        </p:nvSpPr>
        <p:spPr>
          <a:xfrm>
            <a:off x="6334898" y="760057"/>
            <a:ext cx="16094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$ Other Inpatient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0000000-0008-0000-0B00-00005D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686" y="1382412"/>
            <a:ext cx="5614416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0000000-0008-0000-0B00-0000B2000000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4898" y="1382412"/>
            <a:ext cx="5614416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FEF91FA-443F-86FA-0F09-51DEC24CBC85}"/>
              </a:ext>
            </a:extLst>
          </p:cNvPr>
          <p:cNvSpPr txBox="1"/>
          <p:nvPr/>
        </p:nvSpPr>
        <p:spPr>
          <a:xfrm>
            <a:off x="242014" y="233436"/>
            <a:ext cx="9330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ppendix Figure 1.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rends in Racial Disparities in Healthcare Expenditures for 17 Cares.</a:t>
            </a:r>
            <a:endParaRPr lang="en-US" sz="18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57919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244122" y="375368"/>
            <a:ext cx="1776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$ SNF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0245B5-E599-D50F-7A48-B2A4886489CD}"/>
              </a:ext>
            </a:extLst>
          </p:cNvPr>
          <p:cNvSpPr txBox="1"/>
          <p:nvPr/>
        </p:nvSpPr>
        <p:spPr>
          <a:xfrm>
            <a:off x="6446450" y="375367"/>
            <a:ext cx="16094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$ Hospic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0000000-0008-0000-0B00-0000B2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687" y="982362"/>
            <a:ext cx="5614416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B00-0000C2000000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4899" y="982362"/>
            <a:ext cx="5614416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390922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244122" y="375368"/>
            <a:ext cx="1776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$ Home Health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0000000-0008-0000-0B00-0000C6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685" y="982362"/>
            <a:ext cx="5614416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140064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244122" y="375368"/>
            <a:ext cx="20208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 $ Hospital Outpatien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0245B5-E599-D50F-7A48-B2A4886489CD}"/>
              </a:ext>
            </a:extLst>
          </p:cNvPr>
          <p:cNvSpPr txBox="1"/>
          <p:nvPr/>
        </p:nvSpPr>
        <p:spPr>
          <a:xfrm>
            <a:off x="6446450" y="375367"/>
            <a:ext cx="20208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$ Ambulatory Surger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0000000-0008-0000-0B00-000056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122" y="1143000"/>
            <a:ext cx="5614416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0000000-0008-0000-0B00-000056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3464" y="1143000"/>
            <a:ext cx="5614416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545342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244122" y="375368"/>
            <a:ext cx="18772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 $ Part B Dru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0245B5-E599-D50F-7A48-B2A4886489CD}"/>
              </a:ext>
            </a:extLst>
          </p:cNvPr>
          <p:cNvSpPr txBox="1"/>
          <p:nvPr/>
        </p:nvSpPr>
        <p:spPr>
          <a:xfrm>
            <a:off x="6446450" y="375367"/>
            <a:ext cx="2624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. $ Evaluation and Management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0000000-0008-0000-0B00-0000CE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120" y="1149350"/>
            <a:ext cx="5614416" cy="4565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B00-0000DA000000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3466" y="1146175"/>
            <a:ext cx="5614416" cy="4565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981045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244122" y="375368"/>
            <a:ext cx="18772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. $ Anesthesi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0245B5-E599-D50F-7A48-B2A4886489CD}"/>
              </a:ext>
            </a:extLst>
          </p:cNvPr>
          <p:cNvSpPr txBox="1"/>
          <p:nvPr/>
        </p:nvSpPr>
        <p:spPr>
          <a:xfrm>
            <a:off x="6446450" y="375367"/>
            <a:ext cx="2624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. $ Dialysi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0000000-0008-0000-0B00-0000DE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118" y="1146175"/>
            <a:ext cx="5614416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B00-000002010000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3468" y="1146175"/>
            <a:ext cx="5614416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3078418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244122" y="375368"/>
            <a:ext cx="18772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$ Other Procedure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0245B5-E599-D50F-7A48-B2A4886489CD}"/>
              </a:ext>
            </a:extLst>
          </p:cNvPr>
          <p:cNvSpPr txBox="1"/>
          <p:nvPr/>
        </p:nvSpPr>
        <p:spPr>
          <a:xfrm>
            <a:off x="6446450" y="375367"/>
            <a:ext cx="2624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$ Imaging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0000000-0008-0000-0B00-0000E7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116" y="1146175"/>
            <a:ext cx="5614416" cy="4565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B00-0000EB000000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3470" y="1149350"/>
            <a:ext cx="5614416" cy="45624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6840015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244122" y="375368"/>
            <a:ext cx="18772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$ Tes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0245B5-E599-D50F-7A48-B2A4886489CD}"/>
              </a:ext>
            </a:extLst>
          </p:cNvPr>
          <p:cNvSpPr txBox="1"/>
          <p:nvPr/>
        </p:nvSpPr>
        <p:spPr>
          <a:xfrm>
            <a:off x="6446450" y="375367"/>
            <a:ext cx="2624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. $ DM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0000000-0008-0000-0B00-0000EF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114" y="1104806"/>
            <a:ext cx="5614416" cy="46483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0000000-0008-0000-0B00-0000F3000000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3472" y="1104806"/>
            <a:ext cx="5614416" cy="46483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9605901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244122" y="375368"/>
            <a:ext cx="20327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$ Other Part B Carrie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0245B5-E599-D50F-7A48-B2A4886489CD}"/>
              </a:ext>
            </a:extLst>
          </p:cNvPr>
          <p:cNvSpPr txBox="1"/>
          <p:nvPr/>
        </p:nvSpPr>
        <p:spPr>
          <a:xfrm>
            <a:off x="6446450" y="375367"/>
            <a:ext cx="2624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Q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$ Part B Physician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0000000-0008-0000-0B00-0000F7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112" y="1104806"/>
            <a:ext cx="5614416" cy="46483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B00-0000FE000000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3474" y="1104805"/>
            <a:ext cx="5614416" cy="46483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193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</TotalTime>
  <Words>107</Words>
  <Application>Microsoft Macintosh PowerPoint</Application>
  <PresentationFormat>Widescreen</PresentationFormat>
  <Paragraphs>27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ik, Seo (NIH/NLM/LHC) [E]</dc:creator>
  <cp:lastModifiedBy>Baik, Seo (NIH/NLM/LHC) [E]</cp:lastModifiedBy>
  <cp:revision>1</cp:revision>
  <dcterms:created xsi:type="dcterms:W3CDTF">2023-03-23T15:19:14Z</dcterms:created>
  <dcterms:modified xsi:type="dcterms:W3CDTF">2023-09-01T14:29:45Z</dcterms:modified>
</cp:coreProperties>
</file>